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4F662A-3541-4804-BF5E-A09149C65D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33008C-0B5F-48D0-BB5E-57E341C6D5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513C8-A0D2-490F-B126-8FA76532D2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4CF2B9-5E87-4884-8C4A-89EABF7F5F9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3B0DC4-88EF-432A-9EAD-C0ED1C13E1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504DEE-A608-458D-87BF-AA41893AA1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C5315-C687-46A3-BEB8-4040D8C6AE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0679E8-B58D-4E6F-993D-3E29E3130C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15190-F0D1-4B22-AA85-8D8B886581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F48D0-3AF7-4A4B-8A0D-981ED71319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602129-1576-4D2C-8C74-01A6480A3F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DF9616-A0AE-42B8-94D5-A12DF8C50E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51298C-DE1C-48A8-9BB7-39F2E47FAC19}" type="slidenum">
              <a:rPr b="0" lang="sv-S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1332000" y="692280"/>
            <a:ext cx="6697440" cy="5367240"/>
          </a:xfrm>
          <a:prstGeom prst="rect">
            <a:avLst/>
          </a:prstGeom>
          <a:ln w="0">
            <a:noFill/>
          </a:ln>
        </p:spPr>
      </p:pic>
      <p:sp>
        <p:nvSpPr>
          <p:cNvPr id="42" name="textruta 2"/>
          <p:cNvSpPr/>
          <p:nvPr/>
        </p:nvSpPr>
        <p:spPr>
          <a:xfrm>
            <a:off x="1042920" y="5877000"/>
            <a:ext cx="5473800" cy="55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7160" bIns="471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000" spc="-1" strike="noStrike">
                <a:solidFill>
                  <a:srgbClr val="5f5f5f"/>
                </a:solidFill>
                <a:latin typeface="Arial"/>
                <a:ea typeface="Arial"/>
              </a:rPr>
              <a:t>Not Excessive n=  392      380      358      316       222       184       107      84        19         14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000" spc="-1" strike="noStrike">
                <a:solidFill>
                  <a:srgbClr val="000000"/>
                </a:solidFill>
                <a:latin typeface="Arial"/>
                <a:ea typeface="Arial"/>
              </a:rPr>
              <a:t>Excessive n=         78        77        66        50         35         30         12        8           2         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"/>
          <p:cNvSpPr/>
          <p:nvPr/>
        </p:nvSpPr>
        <p:spPr>
          <a:xfrm>
            <a:off x="0" y="0"/>
            <a:ext cx="6046920" cy="72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2800" spc="-1" strike="noStrike">
                <a:solidFill>
                  <a:srgbClr val="000000"/>
                </a:solidFill>
                <a:latin typeface="Arial"/>
              </a:rPr>
              <a:t>Figure 2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4427640" y="1268280"/>
            <a:ext cx="1944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most no milk, insufficient or adequ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>
            <a:off x="4932360" y="270828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cess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"/>
          <p:cNvSpPr/>
          <p:nvPr/>
        </p:nvSpPr>
        <p:spPr>
          <a:xfrm>
            <a:off x="2987640" y="4797360"/>
            <a:ext cx="23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Milk production for the first chil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0"/>
          <p:cNvSpPr/>
          <p:nvPr/>
        </p:nvSpPr>
        <p:spPr>
          <a:xfrm>
            <a:off x="3276720" y="5013360"/>
            <a:ext cx="172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Log-Rank P=0.0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ruta 2"/>
          <p:cNvSpPr/>
          <p:nvPr/>
        </p:nvSpPr>
        <p:spPr>
          <a:xfrm>
            <a:off x="6588000" y="5734080"/>
            <a:ext cx="1225800" cy="55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7160" bIns="471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000" spc="-1" strike="noStrike">
                <a:solidFill>
                  <a:srgbClr val="000000"/>
                </a:solidFill>
                <a:latin typeface="Arial"/>
                <a:ea typeface="Arial"/>
              </a:rPr>
              <a:t>No of even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000" spc="-1" strike="noStrike">
                <a:solidFill>
                  <a:srgbClr val="5f5f5f"/>
                </a:solidFill>
                <a:latin typeface="Arial"/>
                <a:ea typeface="Arial"/>
              </a:rPr>
              <a:t>4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000" spc="-1" strike="noStrike">
                <a:solidFill>
                  <a:srgbClr val="000000"/>
                </a:solidFill>
                <a:latin typeface="Arial"/>
                <a:ea typeface="Arial"/>
              </a:rPr>
              <a:t>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7T14:10:52Z</dcterms:created>
  <dc:creator>OFALSTUD</dc:creator>
  <dc:description/>
  <dc:language>en-US</dc:language>
  <cp:lastModifiedBy>Helena Jernström</cp:lastModifiedBy>
  <dcterms:modified xsi:type="dcterms:W3CDTF">2013-06-19T07:19:44Z</dcterms:modified>
  <cp:revision>8</cp:revision>
  <dc:subject/>
  <dc:title>Figure 1a</dc:title>
</cp:coreProperties>
</file>